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63E867-D1F3-4143-BAA3-45CAA9D503C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5583D8-F5D7-4131-B091-4370DC978EA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8DE088-7898-4ED9-AE73-A3ECC830C28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178E99-64CB-4FB5-8367-49F54F4874A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A3FE86-65CD-4839-9667-803846A9F94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516AC2-B4DA-47ED-8303-1B016F0991D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60345F-B982-4EB4-994C-E6E11C1DB4C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B02C98-0670-4857-9B08-9A8BC827034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9E67E7-0668-46E3-9DFF-6DEB23D4B75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78FDCF-68C7-40EF-8E86-A73C1769E1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71B731-7682-41FC-99A2-E3076EFB813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718EE6-C37C-4350-A1E7-D683A8DB0A7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7B102E1-B3B7-4CFF-8D6F-A0104872CD5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0" y="0"/>
          <a:ext cx="9144000" cy="6765840"/>
        </p:xfrm>
        <a:graphic>
          <a:graphicData uri="http://schemas.openxmlformats.org/drawingml/2006/table">
            <a:tbl>
              <a:tblPr/>
              <a:tblGrid>
                <a:gridCol w="250920"/>
                <a:gridCol w="690480"/>
                <a:gridCol w="793800"/>
                <a:gridCol w="372960"/>
                <a:gridCol w="863640"/>
                <a:gridCol w="361800"/>
                <a:gridCol w="568440"/>
                <a:gridCol w="608040"/>
                <a:gridCol w="277920"/>
                <a:gridCol w="801720"/>
                <a:gridCol w="793440"/>
                <a:gridCol w="374760"/>
                <a:gridCol w="863640"/>
                <a:gridCol w="374760"/>
                <a:gridCol w="539640"/>
                <a:gridCol w="608040"/>
              </a:tblGrid>
              <a:tr h="10944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No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Gene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Dex Fold Chang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S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TNF</a:t>
                      </a:r>
                      <a:r>
                        <a:rPr b="0" lang="en-GB" sz="700" spc="-1" strike="noStrike">
                          <a:solidFill>
                            <a:srgbClr val="ffffff"/>
                          </a:solidFill>
                          <a:latin typeface="Symbol"/>
                          <a:ea typeface="Symbol"/>
                        </a:rPr>
                        <a:t></a:t>
                      </a:r>
                      <a:r>
                        <a:rPr b="0" lang="en-GB" sz="7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 Fold Chang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S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Con vs Dex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Con vs TNF</a:t>
                      </a:r>
                      <a:r>
                        <a:rPr b="0" lang="en-GB" sz="700" spc="-1" strike="noStrike">
                          <a:solidFill>
                            <a:srgbClr val="ffffff"/>
                          </a:solidFill>
                          <a:latin typeface="Symbol"/>
                          <a:ea typeface="Symbol"/>
                        </a:rPr>
                        <a:t>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No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Gene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Dex Fold Chang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S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TNF</a:t>
                      </a:r>
                      <a:r>
                        <a:rPr b="0" lang="en-GB" sz="700" spc="-1" strike="noStrike">
                          <a:solidFill>
                            <a:srgbClr val="ffffff"/>
                          </a:solidFill>
                          <a:latin typeface="Symbol"/>
                          <a:ea typeface="Symbol"/>
                        </a:rPr>
                        <a:t></a:t>
                      </a:r>
                      <a:r>
                        <a:rPr b="0" lang="en-GB" sz="7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 Fold Chang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S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Con vs Dex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Con vs TNF</a:t>
                      </a:r>
                      <a:r>
                        <a:rPr b="0" lang="en-GB" sz="700" spc="-1" strike="noStrike">
                          <a:solidFill>
                            <a:srgbClr val="ffffff"/>
                          </a:solidFill>
                          <a:latin typeface="Symbol"/>
                          <a:ea typeface="Symbol"/>
                        </a:rPr>
                        <a:t>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</a:tr>
              <a:tr h="21744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ousekeeping gene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n canonical swnt signalling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80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8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VL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7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744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APDH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nt signalling target gene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020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nt receptor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IRC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0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1124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ZD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7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CND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6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44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ZD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6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DH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</a:tr>
              <a:tr h="11124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ZD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4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6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7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DH1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6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44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ZD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7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DH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4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124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ZD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5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2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DH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3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3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0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44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ZD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DH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6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44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ZD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0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5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4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ER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124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ZD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0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4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UK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44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ZD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4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6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3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3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LDN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.1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3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</a:tr>
              <a:tr h="11124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RP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3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7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USB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0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44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RP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PRT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124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LAUR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1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P2K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020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nt agonist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P3K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0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NT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P3K1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7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88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NT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P3K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NT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P3K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6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5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</a:tr>
              <a:tr h="11088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NT3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P3K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44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NT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3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2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P3K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7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NT5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0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7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2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PK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88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NT7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PK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NT10B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6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MP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3.3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8.5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6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6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</a:tr>
              <a:tr h="11088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NT1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5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7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Y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6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6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</a:tr>
              <a:tr h="16056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nt antagonist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FAT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7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44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KK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2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7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FATC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124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KK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2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2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4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LCG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3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44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KK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PAR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0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124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KK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PP3C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6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0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44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RZB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.6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KC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5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6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124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IF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6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KCB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2220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anonical signalling mediator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KC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0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0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88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P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7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KC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0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XIN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0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KCI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88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TNNA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KCZ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6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7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</a:tr>
              <a:tr h="10980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TNNB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6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3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TGS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6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.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7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</a:tr>
              <a:tr h="10944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SK3B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AC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124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JUN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MARCA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44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EF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8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7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FAM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124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CF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P5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0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44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CF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0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VIM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5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</a:tr>
              <a:tr h="11124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CF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7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ZEB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6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564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CF7L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ranscription factor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976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egradation of beta catenin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EBPB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3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1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1124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SMB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9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REB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44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SMB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6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6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6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REBBP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124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SMC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3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OSL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4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6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1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6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44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BB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2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NF1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44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B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0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0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NF1B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124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B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2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9.4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6.3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NF4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44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ES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5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6-19T21:45:45Z</dcterms:created>
  <dc:creator>The Medical School</dc:creator>
  <dc:description/>
  <dc:language>en-US</dc:language>
  <cp:lastModifiedBy>The Medical School</cp:lastModifiedBy>
  <dcterms:modified xsi:type="dcterms:W3CDTF">2012-04-03T17:35:35Z</dcterms:modified>
  <cp:revision>74</cp:revision>
  <dc:subject/>
  <dc:title>Slide 1</dc:title>
</cp:coreProperties>
</file>